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200" d="100"/>
          <a:sy n="200" d="100"/>
        </p:scale>
        <p:origin x="-72" y="-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846102-B330-4BC4-BBCF-D4961847942A}" type="datetimeFigureOut">
              <a:rPr lang="en-GB" smtClean="0"/>
              <a:t>27/10/2016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4749CC-D2CC-416A-B526-699E083CF4B7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316702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846102-B330-4BC4-BBCF-D4961847942A}" type="datetimeFigureOut">
              <a:rPr lang="en-GB" smtClean="0"/>
              <a:t>27/10/2016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4749CC-D2CC-416A-B526-699E083CF4B7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711743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846102-B330-4BC4-BBCF-D4961847942A}" type="datetimeFigureOut">
              <a:rPr lang="en-GB" smtClean="0"/>
              <a:t>27/10/2016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4749CC-D2CC-416A-B526-699E083CF4B7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199285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846102-B330-4BC4-BBCF-D4961847942A}" type="datetimeFigureOut">
              <a:rPr lang="en-GB" smtClean="0"/>
              <a:t>27/10/2016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4749CC-D2CC-416A-B526-699E083CF4B7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626176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846102-B330-4BC4-BBCF-D4961847942A}" type="datetimeFigureOut">
              <a:rPr lang="en-GB" smtClean="0"/>
              <a:t>27/10/2016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4749CC-D2CC-416A-B526-699E083CF4B7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466829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846102-B330-4BC4-BBCF-D4961847942A}" type="datetimeFigureOut">
              <a:rPr lang="en-GB" smtClean="0"/>
              <a:t>27/10/2016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4749CC-D2CC-416A-B526-699E083CF4B7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758747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846102-B330-4BC4-BBCF-D4961847942A}" type="datetimeFigureOut">
              <a:rPr lang="en-GB" smtClean="0"/>
              <a:t>27/10/2016</a:t>
            </a:fld>
            <a:endParaRPr lang="en-GB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4749CC-D2CC-416A-B526-699E083CF4B7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38212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846102-B330-4BC4-BBCF-D4961847942A}" type="datetimeFigureOut">
              <a:rPr lang="en-GB" smtClean="0"/>
              <a:t>27/10/2016</a:t>
            </a:fld>
            <a:endParaRPr lang="en-GB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4749CC-D2CC-416A-B526-699E083CF4B7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452551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846102-B330-4BC4-BBCF-D4961847942A}" type="datetimeFigureOut">
              <a:rPr lang="en-GB" smtClean="0"/>
              <a:t>27/10/2016</a:t>
            </a:fld>
            <a:endParaRPr lang="en-GB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4749CC-D2CC-416A-B526-699E083CF4B7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023370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846102-B330-4BC4-BBCF-D4961847942A}" type="datetimeFigureOut">
              <a:rPr lang="en-GB" smtClean="0"/>
              <a:t>27/10/2016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4749CC-D2CC-416A-B526-699E083CF4B7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012474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846102-B330-4BC4-BBCF-D4961847942A}" type="datetimeFigureOut">
              <a:rPr lang="en-GB" smtClean="0"/>
              <a:t>27/10/2016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4749CC-D2CC-416A-B526-699E083CF4B7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18896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846102-B330-4BC4-BBCF-D4961847942A}" type="datetimeFigureOut">
              <a:rPr lang="en-GB" smtClean="0"/>
              <a:t>27/10/2016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4749CC-D2CC-416A-B526-699E083CF4B7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297498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hteck 3"/>
          <p:cNvSpPr/>
          <p:nvPr/>
        </p:nvSpPr>
        <p:spPr>
          <a:xfrm>
            <a:off x="1547664" y="188640"/>
            <a:ext cx="5472608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</a:t>
            </a:r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 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lignment of </a:t>
            </a:r>
            <a:r>
              <a:rPr lang="en-US" sz="11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oxA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ositive </a:t>
            </a:r>
            <a:r>
              <a:rPr lang="en-US" sz="11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asteurella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pp. Swiss field strains</a:t>
            </a:r>
            <a:endParaRPr lang="en-GB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Rechteck 6"/>
          <p:cNvSpPr/>
          <p:nvPr/>
        </p:nvSpPr>
        <p:spPr>
          <a:xfrm>
            <a:off x="974169" y="5786375"/>
            <a:ext cx="6550159" cy="93871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2 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quence alignment of a partial </a:t>
            </a:r>
            <a:r>
              <a:rPr lang="en-US" sz="11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oxA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sequence of </a:t>
            </a:r>
            <a:r>
              <a:rPr lang="fr-CH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. </a:t>
            </a:r>
            <a:r>
              <a:rPr lang="fr-CH" sz="11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ultocida</a:t>
            </a:r>
            <a:r>
              <a:rPr lang="fr-CH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ference strain (</a:t>
            </a:r>
            <a:r>
              <a:rPr lang="en-US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nBank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ccession number: 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F240778.1) to three </a:t>
            </a:r>
            <a:r>
              <a:rPr lang="en-US" sz="11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oxA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positive </a:t>
            </a:r>
            <a:r>
              <a:rPr lang="en-US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. </a:t>
            </a:r>
            <a:r>
              <a:rPr lang="en-US" sz="11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ultocida</a:t>
            </a:r>
            <a:r>
              <a:rPr lang="en-US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wiss field strains (ZH 16788, ZH 16648 and ZH 16752) and to one </a:t>
            </a:r>
            <a:r>
              <a:rPr lang="en-US" sz="11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oxA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positive </a:t>
            </a:r>
            <a:r>
              <a:rPr lang="en-US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. </a:t>
            </a:r>
            <a:r>
              <a:rPr lang="en-US" sz="11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nis</a:t>
            </a:r>
            <a:r>
              <a:rPr lang="en-US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wiss field strain (ZH 401).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imer regions 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 the </a:t>
            </a:r>
            <a:r>
              <a:rPr lang="en-US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qRT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PCR are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dicated 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 grey arrows, the probe is highlighted in blue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tching residues are marked as dots. 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oint mutations found in the </a:t>
            </a:r>
            <a:r>
              <a:rPr lang="en-GB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. </a:t>
            </a:r>
            <a:r>
              <a:rPr lang="en-GB" sz="11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nis</a:t>
            </a:r>
            <a:r>
              <a:rPr lang="en-GB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rain ZH 401 have a red background colour.</a:t>
            </a:r>
            <a:endParaRPr lang="en-GB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Picture 3" descr="C:\Users\ss\Desktop\toxA_AF240778.1 alignment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76215" y="484346"/>
            <a:ext cx="6052526" cy="53303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1246353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8</Words>
  <Application>Microsoft Office PowerPoint</Application>
  <PresentationFormat>Bildschirmpräsentation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imone Scherrer</dc:creator>
  <cp:lastModifiedBy>Simone Scherrer</cp:lastModifiedBy>
  <cp:revision>15</cp:revision>
  <dcterms:created xsi:type="dcterms:W3CDTF">2016-06-29T11:21:39Z</dcterms:created>
  <dcterms:modified xsi:type="dcterms:W3CDTF">2016-10-27T09:03:56Z</dcterms:modified>
</cp:coreProperties>
</file>